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jpeg" ContentType="image/jpeg"/>
  <Override PartName="/ppt/media/image4.jpeg" ContentType="image/jpe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D9D10-280E-41E4-8BB9-3D663020C1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14C23-7EE9-476E-BA75-0C7BA653B7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267C7-586C-442E-A691-0DBBE06CB9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7D41D-8919-4167-AEEF-FCD7C335DC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78EBD-DF8C-46B3-873F-9BE7B01DE7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9A12DE-D60B-4E04-B90B-3240D48C4B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9EAB3-0802-4250-8847-CE8C3A3BB0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03839B-2197-417C-88A0-2CB6082B3E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E5BA6-D1A4-43DB-B809-E1C3174104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B484F8-2A18-4E1C-AA21-5A2BC6F364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3F598-3E69-45EF-9C4F-626A563F13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592256-8156-4306-AB83-C0D27E14D0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BE64D8-F615-467A-8F04-4381907B511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851"/>
          <p:cNvSpPr/>
          <p:nvPr/>
        </p:nvSpPr>
        <p:spPr>
          <a:xfrm>
            <a:off x="214200" y="857160"/>
            <a:ext cx="100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TABLE I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571680" y="639720"/>
          <a:ext cx="5643360" cy="3718080"/>
        </p:xfrm>
        <a:graphic>
          <a:graphicData uri="http://schemas.openxmlformats.org/drawingml/2006/table">
            <a:tbl>
              <a:tblPr/>
              <a:tblGrid>
                <a:gridCol w="745920"/>
                <a:gridCol w="1087560"/>
                <a:gridCol w="533160"/>
                <a:gridCol w="627120"/>
                <a:gridCol w="571680"/>
                <a:gridCol w="747720"/>
                <a:gridCol w="593640"/>
                <a:gridCol w="736560"/>
              </a:tblGrid>
              <a:tr h="5205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mb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ype Loc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im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l.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yr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MB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ss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dne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lee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ar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ymph no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ymph no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eu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eur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T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ymph no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T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ymph no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285840" y="4316400"/>
          <a:ext cx="6000840" cy="4322880"/>
        </p:xfrm>
        <a:graphic>
          <a:graphicData uri="http://schemas.openxmlformats.org/drawingml/2006/table">
            <a:tbl>
              <a:tblPr/>
              <a:tblGrid>
                <a:gridCol w="701640"/>
                <a:gridCol w="358560"/>
                <a:gridCol w="357480"/>
                <a:gridCol w="355320"/>
                <a:gridCol w="358920"/>
                <a:gridCol w="355680"/>
                <a:gridCol w="358560"/>
                <a:gridCol w="355680"/>
                <a:gridCol w="358920"/>
                <a:gridCol w="301680"/>
                <a:gridCol w="358560"/>
                <a:gridCol w="357120"/>
                <a:gridCol w="357480"/>
                <a:gridCol w="357120"/>
                <a:gridCol w="355680"/>
                <a:gridCol w="352440"/>
              </a:tblGrid>
              <a:tr h="5205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14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20560"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l. Nr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X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2b2b2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Rectangle 6"/>
          <p:cNvSpPr/>
          <p:nvPr/>
        </p:nvSpPr>
        <p:spPr>
          <a:xfrm>
            <a:off x="214200" y="4673520"/>
            <a:ext cx="96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23"/>
          <p:cNvSpPr/>
          <p:nvPr/>
        </p:nvSpPr>
        <p:spPr>
          <a:xfrm>
            <a:off x="142920" y="0"/>
            <a:ext cx="292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upplementary TABL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 Box 44"/>
          <p:cNvSpPr/>
          <p:nvPr/>
        </p:nvSpPr>
        <p:spPr>
          <a:xfrm>
            <a:off x="4002120" y="10033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30" descr="G:\Mig-pulsed.jpg"/>
          <p:cNvPicPr/>
          <p:nvPr/>
        </p:nvPicPr>
        <p:blipFill>
          <a:blip r:embed="rId1"/>
          <a:srcRect l="7148" t="8828" r="27751" b="2949"/>
          <a:stretch/>
        </p:blipFill>
        <p:spPr>
          <a:xfrm>
            <a:off x="4286160" y="1666800"/>
            <a:ext cx="1951200" cy="171468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3" descr="Chart3"/>
          <p:cNvPicPr/>
          <p:nvPr/>
        </p:nvPicPr>
        <p:blipFill>
          <a:blip r:embed="rId2"/>
          <a:srcRect l="89576" t="13856" r="8108" b="80919"/>
          <a:stretch/>
        </p:blipFill>
        <p:spPr>
          <a:xfrm>
            <a:off x="3857760" y="3332160"/>
            <a:ext cx="357120" cy="3571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3" descr="Chart3"/>
          <p:cNvPicPr/>
          <p:nvPr/>
        </p:nvPicPr>
        <p:blipFill>
          <a:blip r:embed="rId3"/>
          <a:srcRect l="90039" t="21812" r="8108" b="75687"/>
          <a:stretch/>
        </p:blipFill>
        <p:spPr>
          <a:xfrm>
            <a:off x="3871800" y="3689280"/>
            <a:ext cx="357480" cy="214560"/>
          </a:xfrm>
          <a:prstGeom prst="rect">
            <a:avLst/>
          </a:prstGeom>
          <a:ln w="0">
            <a:noFill/>
          </a:ln>
        </p:spPr>
      </p:pic>
      <p:sp>
        <p:nvSpPr>
          <p:cNvPr id="50" name="Text Box 18"/>
          <p:cNvSpPr/>
          <p:nvPr/>
        </p:nvSpPr>
        <p:spPr>
          <a:xfrm>
            <a:off x="4173120" y="3236760"/>
            <a:ext cx="2404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.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l-7pulsed with 0ng CXCL9/m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l-7pulsed with 200ng CXCL9/m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6"/>
          <p:cNvSpPr/>
          <p:nvPr/>
        </p:nvSpPr>
        <p:spPr>
          <a:xfrm>
            <a:off x="4730040" y="1413000"/>
            <a:ext cx="109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lanoma-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8"/>
          <p:cNvSpPr/>
          <p:nvPr/>
        </p:nvSpPr>
        <p:spPr>
          <a:xfrm rot="16200000">
            <a:off x="3425400" y="2234160"/>
            <a:ext cx="156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rmalized Impeda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20" descr="Z:\Desktop_daten\Research\Interreg CKn\Experiments\Migration\20060922\20060922_LEC-MIG_TNF+RQII_trail1_6h_ckn.jpg"/>
          <p:cNvPicPr/>
          <p:nvPr/>
        </p:nvPicPr>
        <p:blipFill>
          <a:blip r:embed="rId4"/>
          <a:srcRect l="8206" t="8176" r="24308" b="3927"/>
          <a:stretch/>
        </p:blipFill>
        <p:spPr>
          <a:xfrm>
            <a:off x="785880" y="1785960"/>
            <a:ext cx="2143080" cy="162252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20" descr="Z:\Desktop_daten\Research\Interreg CKn\Experiments\Migration\20060922\20060922_LEC-MIG_TNF+RQII_trail1_6h_ckn.jpg"/>
          <p:cNvPicPr/>
          <p:nvPr/>
        </p:nvPicPr>
        <p:blipFill>
          <a:blip r:embed="rId5"/>
          <a:srcRect l="76780" t="13371" r="17685" b="79149"/>
          <a:stretch/>
        </p:blipFill>
        <p:spPr>
          <a:xfrm>
            <a:off x="1270080" y="3651120"/>
            <a:ext cx="285840" cy="500040"/>
          </a:xfrm>
          <a:prstGeom prst="rect">
            <a:avLst/>
          </a:prstGeom>
          <a:ln w="0">
            <a:noFill/>
          </a:ln>
        </p:spPr>
      </p:pic>
      <p:sp>
        <p:nvSpPr>
          <p:cNvPr id="55" name="Text Box 44"/>
          <p:cNvSpPr/>
          <p:nvPr/>
        </p:nvSpPr>
        <p:spPr>
          <a:xfrm>
            <a:off x="930600" y="10000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8"/>
          <p:cNvSpPr/>
          <p:nvPr/>
        </p:nvSpPr>
        <p:spPr>
          <a:xfrm>
            <a:off x="1505880" y="3571920"/>
            <a:ext cx="1291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.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N (Melanoma-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0ng CXCL9/m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8"/>
          <p:cNvSpPr/>
          <p:nvPr/>
        </p:nvSpPr>
        <p:spPr>
          <a:xfrm rot="16200000">
            <a:off x="295920" y="2364480"/>
            <a:ext cx="84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mpeda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6"/>
          <p:cNvSpPr/>
          <p:nvPr/>
        </p:nvSpPr>
        <p:spPr>
          <a:xfrm>
            <a:off x="1356840" y="1552680"/>
            <a:ext cx="109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lanoma-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3"/>
          <p:cNvSpPr/>
          <p:nvPr/>
        </p:nvSpPr>
        <p:spPr>
          <a:xfrm>
            <a:off x="214200" y="1071720"/>
            <a:ext cx="1500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3"/>
          <p:cNvSpPr/>
          <p:nvPr/>
        </p:nvSpPr>
        <p:spPr>
          <a:xfrm>
            <a:off x="142920" y="0"/>
            <a:ext cx="292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>
            <a:lum contrast="20000"/>
          </a:blip>
          <a:srcRect l="0" t="0" r="0" b="8943"/>
          <a:stretch/>
        </p:blipFill>
        <p:spPr>
          <a:xfrm>
            <a:off x="3584520" y="1273320"/>
            <a:ext cx="2129040" cy="155736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2">
            <a:lum contrast="20000"/>
          </a:blip>
          <a:srcRect l="0" t="0" r="0" b="8957"/>
          <a:stretch/>
        </p:blipFill>
        <p:spPr>
          <a:xfrm>
            <a:off x="1063800" y="1273320"/>
            <a:ext cx="2127240" cy="155736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1398600" y="2882880"/>
            <a:ext cx="43718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210120" y="2970360"/>
            <a:ext cx="52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PP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0800000">
            <a:off x="878040" y="1672920"/>
            <a:ext cx="393480" cy="54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CD3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860640" y="1116000"/>
            <a:ext cx="190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Normal Sk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507680" y="1152360"/>
            <a:ext cx="202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Melanoma metasta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3"/>
          <p:cNvSpPr/>
          <p:nvPr/>
        </p:nvSpPr>
        <p:spPr>
          <a:xfrm>
            <a:off x="142920" y="0"/>
            <a:ext cx="292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02T09:18:25Z</dcterms:created>
  <dc:creator>christoph</dc:creator>
  <dc:description/>
  <dc:language>en-US</dc:language>
  <cp:lastModifiedBy>S.Bigmore</cp:lastModifiedBy>
  <dcterms:modified xsi:type="dcterms:W3CDTF">2010-12-17T08:51:05Z</dcterms:modified>
  <cp:revision>566</cp:revision>
  <dc:subject/>
  <dc:title>Folie 1</dc:title>
</cp:coreProperties>
</file>